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91" r:id="rId2"/>
    <p:sldId id="38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FF"/>
    <a:srgbClr val="000000"/>
    <a:srgbClr val="E9E9E3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9685" autoAdjust="0"/>
  </p:normalViewPr>
  <p:slideViewPr>
    <p:cSldViewPr>
      <p:cViewPr>
        <p:scale>
          <a:sx n="124" d="100"/>
          <a:sy n="124" d="100"/>
        </p:scale>
        <p:origin x="-1170" y="-216"/>
      </p:cViewPr>
      <p:guideLst>
        <p:guide orient="horz" pos="19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819470-2419-4F23-988C-F89AD1CED4E2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773480-6965-4A88-BE7F-C53CE31929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581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FIGURE 2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LSC segmentation scheme</a:t>
            </a:r>
          </a:p>
          <a:p>
            <a:r>
              <a:rPr lang="en-US" dirty="0" smtClean="0"/>
              <a:t>COLO205 tumor sections</a:t>
            </a:r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457200" y="177225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3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7200" y="3429000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3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600200" y="685800"/>
            <a:ext cx="5791200" cy="5813818"/>
            <a:chOff x="1600200" y="685800"/>
            <a:chExt cx="5791200" cy="5813818"/>
          </a:xfrm>
        </p:grpSpPr>
        <p:pic>
          <p:nvPicPr>
            <p:cNvPr id="5" name="Picture 10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600200" y="4292607"/>
              <a:ext cx="2179334" cy="219654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</p:spPr>
        </p:pic>
        <p:pic>
          <p:nvPicPr>
            <p:cNvPr id="310274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2439" t="61026" b="2359"/>
            <a:stretch>
              <a:fillRect/>
            </a:stretch>
          </p:blipFill>
          <p:spPr bwMode="auto">
            <a:xfrm rot="5400000">
              <a:off x="5773288" y="4962930"/>
              <a:ext cx="2211960" cy="8294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" name="TextBox 9"/>
            <p:cNvSpPr txBox="1"/>
            <p:nvPr/>
          </p:nvSpPr>
          <p:spPr>
            <a:xfrm>
              <a:off x="6379584" y="3805535"/>
              <a:ext cx="10118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Relocation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Gallery (R1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Group 12"/>
            <p:cNvGrpSpPr/>
            <p:nvPr/>
          </p:nvGrpSpPr>
          <p:grpSpPr>
            <a:xfrm>
              <a:off x="4047850" y="4282136"/>
              <a:ext cx="2179334" cy="2217482"/>
              <a:chOff x="815720" y="-7938"/>
              <a:chExt cx="6812217" cy="6865938"/>
            </a:xfrm>
          </p:grpSpPr>
          <p:pic>
            <p:nvPicPr>
              <p:cNvPr id="14" name="Picture 3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838200" y="-7938"/>
                <a:ext cx="6789737" cy="68659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" name="Picture 11"/>
              <p:cNvPicPr>
                <a:picLocks noChangeAspect="1" noChangeArrowheads="1"/>
              </p:cNvPicPr>
              <p:nvPr/>
            </p:nvPicPr>
            <p:blipFill>
              <a:blip r:embed="rId5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/>
              <a:stretch>
                <a:fillRect/>
              </a:stretch>
            </p:blipFill>
            <p:spPr bwMode="auto">
              <a:xfrm>
                <a:off x="815720" y="0"/>
                <a:ext cx="6804280" cy="6858000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</p:spPr>
          </p:pic>
        </p:grpSp>
        <p:sp>
          <p:nvSpPr>
            <p:cNvPr id="16" name="Rectangle 15"/>
            <p:cNvSpPr/>
            <p:nvPr/>
          </p:nvSpPr>
          <p:spPr>
            <a:xfrm>
              <a:off x="4083116" y="3810000"/>
              <a:ext cx="2197589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-Histone H3 + Objects (R1)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Relocation on Tumor Section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057400" y="3810000"/>
              <a:ext cx="13949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re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s. </a:t>
              </a: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p-Histone H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1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779971" y="1116590"/>
              <a:ext cx="5611429" cy="20838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" name="TextBox 20"/>
            <p:cNvSpPr txBox="1"/>
            <p:nvPr/>
          </p:nvSpPr>
          <p:spPr>
            <a:xfrm>
              <a:off x="5437917" y="685800"/>
              <a:ext cx="195348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Tumor Contour (phantom)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ircle Grid</a:t>
              </a:r>
              <a:r>
                <a:rPr lang="en-US" sz="1200" dirty="0">
                  <a:latin typeface="Arial" pitchFamily="34" charset="0"/>
                  <a:cs typeface="Arial" pitchFamily="34" charset="0"/>
                </a:rPr>
                <a:t>, 10 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Micron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874533" y="685800"/>
              <a:ext cx="139493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nti-p-Histone H3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Object </a:t>
              </a:r>
              <a:r>
                <a:rPr lang="en-US" sz="1200" dirty="0"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ontour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997482" y="685800"/>
              <a:ext cx="162050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NA Content (DAPI) </a:t>
              </a: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p-Histone H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200400" y="5415197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Straight Arrow Connector 27"/>
            <p:cNvCxnSpPr/>
            <p:nvPr/>
          </p:nvCxnSpPr>
          <p:spPr>
            <a:xfrm>
              <a:off x="3463383" y="5257800"/>
              <a:ext cx="46047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86</TotalTime>
  <Words>54</Words>
  <Application>Microsoft Office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upplementary FIGURE 2</vt:lpstr>
      <vt:lpstr>PowerPoint Presentation</vt:lpstr>
    </vt:vector>
  </TitlesOfParts>
  <Company>Amgen Employ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juan</dc:creator>
  <cp:lastModifiedBy>gjuan</cp:lastModifiedBy>
  <cp:revision>380</cp:revision>
  <dcterms:created xsi:type="dcterms:W3CDTF">2011-03-21T15:57:54Z</dcterms:created>
  <dcterms:modified xsi:type="dcterms:W3CDTF">2014-09-10T22:41:20Z</dcterms:modified>
</cp:coreProperties>
</file>